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55F6B-3502-426A-3AD6-17D2391EEB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1665EA-E854-9C37-74BE-8B9F4B4CD5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0ABD15-952D-75D9-95FB-65858F04F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79C93B-DC3F-5E82-6126-830AF38F4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BBD7DB-DB4F-765F-8E0E-29FD0EC81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98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0F8AF-5228-E920-AFC6-DE796A772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D4227C-E6C8-0DA5-C32A-E008180266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FBCF06-B82B-0029-D900-2750F16F5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76D534-BC03-A674-5BB1-F20B6AB9D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3D90F-B102-4BE3-9874-4891D9394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676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D28828-316D-7406-4ED4-10A7C7DF19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186FD2-8452-59CD-8870-5E99A323CF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DEA895-361A-20F0-B22E-7861280B6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0F817D-B87A-0AE0-B139-8E31FEFA3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6ED021-294E-817B-79D0-DC4F07FD9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559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22BEC-915A-3C61-9358-5BD6CFEA8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4A44FB-3F38-C152-D54B-489C248697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B2DA78-0ECB-B0CD-28B5-2D828336D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D191A-326F-A37A-8D07-C80C5F83C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6BABB3-9EEA-0250-73AD-1B524DD54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728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9A203-EC02-90F8-C763-FB2E9F2DE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3D8127-80D8-4317-D7E1-FC332A2CB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CEAAF1-CA17-B91E-FCF4-D218CEDE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9B746D-AD0F-23B3-7994-AB0044CCB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DBF28-C628-B5CD-6463-74A15AE38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82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25749-A432-559A-F5CF-F3638415C7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FA1FA5-4C4C-B123-3966-FE21A41089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F1D822-469F-D8AF-88C1-6B5F1B1FC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C262C-2272-D9BB-7CAE-B739974DF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35C1E8-5A7E-FF44-36E3-AEAC3E5EF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F300B6-0F7B-D420-E19A-AC6F0AECA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689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A06F5-F2D5-D5EF-8096-8C739D13B1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C68DF3-084F-5290-D39E-DCC4742B0C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6C6BF7-8832-9FDC-7D41-AA83D4E07E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7F9FF2-EE81-1816-430B-D6F8053F75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3839CB-82A6-8073-1AB7-6FCAAF6005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353739-728B-DF6A-5ECB-F148F77F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2B2E6E-A176-B03D-B761-EF29B8605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84EA7BF-1122-1135-7756-C5337C8C4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138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B9F63-E1A2-CBE7-B6E8-D204839C15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9CDDE0-CE51-6E28-16C6-9CA1D35EE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E6BDE8-81CF-4CA2-F892-94BBEE9C3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8DB5B4-7E01-04F7-1CAF-13EBA7047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012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6901AD-84D7-46BC-DEFC-F9DC98273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6F92FD-DEF7-5FE5-DDF2-5E50938CC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37063C-2260-73F6-13A7-331106AE5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114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243682-2E92-DA4A-ECE0-9DB009142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2B6B19-F777-4CBF-6DF7-D4D48525DD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73005C-A84E-E65C-70DC-6D4361E75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4B80A2-0C07-81D4-C86C-A82131B5D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043467-605E-94C3-125D-687BE1200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26F2FF-ADF5-8E25-305D-9D0209DD6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756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0BA56C-9461-5E37-C097-B051F0C32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EB5E8F-AD01-0F97-552A-1C8F3A68FB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8027A1-690C-2A73-A52F-70652DAE84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8A5933-CF9F-C673-EF74-3AE9577F3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466ABF-0CDA-A826-3377-668B1536B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88706A-CE69-D88C-2C49-45822F055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42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0204C0-D367-D2C4-CC32-C6DBB83AA5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41DA90-8C7F-679B-01C6-7F1BF5D4CF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F4CE43-5E7E-1362-DD4C-D5FF68B12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7771D-FD7D-453F-AF21-661D72257C1F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63B014-4A5C-1850-EE4A-5B679636D7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A5887-2AEE-8C3A-FC30-F497B6DA59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6B22B-2D5B-4B92-8E1F-26AFC6AC1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653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7B78881-D4D4-89C8-6E0C-66CD4630A91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2" t="28179" r="6886" b="29556"/>
          <a:stretch/>
        </p:blipFill>
        <p:spPr>
          <a:xfrm>
            <a:off x="2596946" y="1980317"/>
            <a:ext cx="6122125" cy="221829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84DB27F-6DEE-DB6A-0697-0A42C42ED70F}"/>
              </a:ext>
            </a:extLst>
          </p:cNvPr>
          <p:cNvSpPr txBox="1"/>
          <p:nvPr/>
        </p:nvSpPr>
        <p:spPr>
          <a:xfrm>
            <a:off x="2596944" y="1109878"/>
            <a:ext cx="69981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. Comparison of study-provided and commercially available bouillon cubes</a:t>
            </a:r>
            <a:r>
              <a:rPr lang="en-US" b="1" baseline="30000" dirty="0"/>
              <a:t>1</a:t>
            </a:r>
            <a:endParaRPr lang="en-US" b="1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7B63C7F-F67A-E035-E6AB-73E308FC13B2}"/>
              </a:ext>
            </a:extLst>
          </p:cNvPr>
          <p:cNvGrpSpPr/>
          <p:nvPr/>
        </p:nvGrpSpPr>
        <p:grpSpPr>
          <a:xfrm>
            <a:off x="2596944" y="1974792"/>
            <a:ext cx="6122126" cy="2218291"/>
            <a:chOff x="3091543" y="2375387"/>
            <a:chExt cx="6122126" cy="2218291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E5F96C2-996B-BDBF-9A84-6E2249C4C388}"/>
                </a:ext>
              </a:extLst>
            </p:cNvPr>
            <p:cNvSpPr txBox="1"/>
            <p:nvPr/>
          </p:nvSpPr>
          <p:spPr>
            <a:xfrm>
              <a:off x="3091543" y="2375388"/>
              <a:ext cx="2373083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Study provided bouillon cubes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D15344A-A416-85F1-8B17-C97AA834EFBE}"/>
                </a:ext>
              </a:extLst>
            </p:cNvPr>
            <p:cNvSpPr txBox="1"/>
            <p:nvPr/>
          </p:nvSpPr>
          <p:spPr>
            <a:xfrm>
              <a:off x="5455920" y="2375387"/>
              <a:ext cx="3757749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Commercially available bouillon cub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31B7476-0378-5696-ACCC-4B6CAA7E54A7}"/>
                </a:ext>
              </a:extLst>
            </p:cNvPr>
            <p:cNvSpPr txBox="1"/>
            <p:nvPr/>
          </p:nvSpPr>
          <p:spPr>
            <a:xfrm>
              <a:off x="3091543" y="2652386"/>
              <a:ext cx="2373083" cy="19389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A0D45C9-51EC-5E0F-C5AC-7F594A8DC11F}"/>
                </a:ext>
              </a:extLst>
            </p:cNvPr>
            <p:cNvSpPr txBox="1"/>
            <p:nvPr/>
          </p:nvSpPr>
          <p:spPr>
            <a:xfrm>
              <a:off x="5455920" y="2654686"/>
              <a:ext cx="3757749" cy="19389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  <a:p>
              <a:pPr algn="ctr"/>
              <a:endParaRPr lang="en-US" sz="1200" dirty="0"/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B11B6B60-1E9F-35E0-CB63-C35687E78AFD}"/>
              </a:ext>
            </a:extLst>
          </p:cNvPr>
          <p:cNvSpPr txBox="1"/>
          <p:nvPr/>
        </p:nvSpPr>
        <p:spPr>
          <a:xfrm>
            <a:off x="2496457" y="4291148"/>
            <a:ext cx="6998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baseline="30000" dirty="0"/>
              <a:t>1</a:t>
            </a:r>
            <a:r>
              <a:rPr lang="en-US" sz="1200" dirty="0"/>
              <a:t>Study-provided bouillon cubes are 10 g; commercially available bouillon cubes are either 10 g or 12 g.</a:t>
            </a:r>
            <a:endParaRPr lang="en-US" sz="1200" b="1" baseline="30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30D5755-F7D4-C13A-84DE-27EC0CE09C9E}"/>
              </a:ext>
            </a:extLst>
          </p:cNvPr>
          <p:cNvSpPr txBox="1"/>
          <p:nvPr/>
        </p:nvSpPr>
        <p:spPr>
          <a:xfrm>
            <a:off x="132710" y="165463"/>
            <a:ext cx="93618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cceptability of multiple micronutrient-fortified bouillon cubes among women and their households in two districts in the Northern region of Ghana</a:t>
            </a:r>
          </a:p>
          <a:p>
            <a:r>
              <a:rPr lang="en-US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Wessells </a:t>
            </a:r>
            <a:r>
              <a:rPr lang="en-US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et al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86006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3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berly Ryan Wessells</dc:creator>
  <cp:lastModifiedBy>Kimberly Ryan Wessells</cp:lastModifiedBy>
  <cp:revision>14</cp:revision>
  <dcterms:created xsi:type="dcterms:W3CDTF">2023-03-24T16:18:38Z</dcterms:created>
  <dcterms:modified xsi:type="dcterms:W3CDTF">2023-11-22T22:07:15Z</dcterms:modified>
</cp:coreProperties>
</file>